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0" d="100"/>
          <a:sy n="120" d="100"/>
        </p:scale>
        <p:origin x="54" y="147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F:\Revise\CI%20calculation\Combination%20of%20PF%20and%20MEK%20inhibitor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8.6071819497899091E-2"/>
          <c:y val="5.6439760661513801E-2"/>
          <c:w val="0.89419138232720896"/>
          <c:h val="0.89435659084281127"/>
        </c:manualLayout>
      </c:layout>
      <c:lineChart>
        <c:grouping val="standard"/>
        <c:varyColors val="0"/>
        <c:ser>
          <c:idx val="0"/>
          <c:order val="0"/>
          <c:tx>
            <c:strRef>
              <c:f>Sheet3!$C$3</c:f>
              <c:strCache>
                <c:ptCount val="1"/>
                <c:pt idx="0">
                  <c:v>PF-06260933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Sheet3!$D$11:$K$11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7.2</c:v>
                  </c:pt>
                  <c:pt idx="2">
                    <c:v>6.2</c:v>
                  </c:pt>
                  <c:pt idx="3">
                    <c:v>3.3</c:v>
                  </c:pt>
                  <c:pt idx="4">
                    <c:v>6.8</c:v>
                  </c:pt>
                  <c:pt idx="5">
                    <c:v>4.3</c:v>
                  </c:pt>
                  <c:pt idx="6">
                    <c:v>3.1</c:v>
                  </c:pt>
                  <c:pt idx="7">
                    <c:v>2.4</c:v>
                  </c:pt>
                </c:numCache>
              </c:numRef>
            </c:plus>
            <c:minus>
              <c:numRef>
                <c:f>Sheet3!$D$11:$K$11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7.2</c:v>
                  </c:pt>
                  <c:pt idx="2">
                    <c:v>6.2</c:v>
                  </c:pt>
                  <c:pt idx="3">
                    <c:v>3.3</c:v>
                  </c:pt>
                  <c:pt idx="4">
                    <c:v>6.8</c:v>
                  </c:pt>
                  <c:pt idx="5">
                    <c:v>4.3</c:v>
                  </c:pt>
                  <c:pt idx="6">
                    <c:v>3.1</c:v>
                  </c:pt>
                  <c:pt idx="7">
                    <c:v>2.4</c:v>
                  </c:pt>
                </c:numCache>
              </c:numRef>
            </c:minus>
          </c:errBars>
          <c:cat>
            <c:strRef>
              <c:f>Sheet3!$D$2:$K$2</c:f>
              <c:strCache>
                <c:ptCount val="8"/>
                <c:pt idx="0">
                  <c:v>0/0</c:v>
                </c:pt>
                <c:pt idx="1">
                  <c:v>100/1</c:v>
                </c:pt>
                <c:pt idx="2">
                  <c:v>200/2</c:v>
                </c:pt>
                <c:pt idx="3">
                  <c:v>250/2.5</c:v>
                </c:pt>
                <c:pt idx="4">
                  <c:v>500/5</c:v>
                </c:pt>
                <c:pt idx="5">
                  <c:v>1000/10</c:v>
                </c:pt>
                <c:pt idx="6">
                  <c:v>2000/20</c:v>
                </c:pt>
                <c:pt idx="7">
                  <c:v>3000/30</c:v>
                </c:pt>
              </c:strCache>
            </c:strRef>
          </c:cat>
          <c:val>
            <c:numRef>
              <c:f>Sheet3!$D$3:$K$3</c:f>
              <c:numCache>
                <c:formatCode>General</c:formatCode>
                <c:ptCount val="8"/>
                <c:pt idx="0">
                  <c:v>100</c:v>
                </c:pt>
                <c:pt idx="1">
                  <c:v>95.666666666666671</c:v>
                </c:pt>
                <c:pt idx="2">
                  <c:v>87.3333333333333</c:v>
                </c:pt>
                <c:pt idx="3">
                  <c:v>80.3333333333333</c:v>
                </c:pt>
                <c:pt idx="4">
                  <c:v>73.3333333333333</c:v>
                </c:pt>
                <c:pt idx="5">
                  <c:v>65.3333333333333</c:v>
                </c:pt>
                <c:pt idx="6">
                  <c:v>47</c:v>
                </c:pt>
                <c:pt idx="7">
                  <c:v>35.666666666666664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Sheet3!$C$4</c:f>
              <c:strCache>
                <c:ptCount val="1"/>
                <c:pt idx="0">
                  <c:v>Trametinib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Sheet3!$D$12:$K$12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6.3</c:v>
                  </c:pt>
                  <c:pt idx="2">
                    <c:v>4.7</c:v>
                  </c:pt>
                  <c:pt idx="3">
                    <c:v>5.3</c:v>
                  </c:pt>
                  <c:pt idx="4">
                    <c:v>4.4000000000000004</c:v>
                  </c:pt>
                  <c:pt idx="5">
                    <c:v>4.0999999999999996</c:v>
                  </c:pt>
                  <c:pt idx="6">
                    <c:v>3.5</c:v>
                  </c:pt>
                  <c:pt idx="7">
                    <c:v>1.8</c:v>
                  </c:pt>
                </c:numCache>
              </c:numRef>
            </c:plus>
            <c:minus>
              <c:numRef>
                <c:f>Sheet3!$D$12:$K$12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6.3</c:v>
                  </c:pt>
                  <c:pt idx="2">
                    <c:v>4.7</c:v>
                  </c:pt>
                  <c:pt idx="3">
                    <c:v>5.3</c:v>
                  </c:pt>
                  <c:pt idx="4">
                    <c:v>4.4000000000000004</c:v>
                  </c:pt>
                  <c:pt idx="5">
                    <c:v>4.0999999999999996</c:v>
                  </c:pt>
                  <c:pt idx="6">
                    <c:v>3.5</c:v>
                  </c:pt>
                  <c:pt idx="7">
                    <c:v>1.8</c:v>
                  </c:pt>
                </c:numCache>
              </c:numRef>
            </c:minus>
          </c:errBars>
          <c:cat>
            <c:strRef>
              <c:f>Sheet3!$D$2:$K$2</c:f>
              <c:strCache>
                <c:ptCount val="8"/>
                <c:pt idx="0">
                  <c:v>0/0</c:v>
                </c:pt>
                <c:pt idx="1">
                  <c:v>100/1</c:v>
                </c:pt>
                <c:pt idx="2">
                  <c:v>200/2</c:v>
                </c:pt>
                <c:pt idx="3">
                  <c:v>250/2.5</c:v>
                </c:pt>
                <c:pt idx="4">
                  <c:v>500/5</c:v>
                </c:pt>
                <c:pt idx="5">
                  <c:v>1000/10</c:v>
                </c:pt>
                <c:pt idx="6">
                  <c:v>2000/20</c:v>
                </c:pt>
                <c:pt idx="7">
                  <c:v>3000/30</c:v>
                </c:pt>
              </c:strCache>
            </c:strRef>
          </c:cat>
          <c:val>
            <c:numRef>
              <c:f>Sheet3!$D$4:$K$4</c:f>
              <c:numCache>
                <c:formatCode>General</c:formatCode>
                <c:ptCount val="8"/>
                <c:pt idx="0">
                  <c:v>100</c:v>
                </c:pt>
                <c:pt idx="1">
                  <c:v>91.333333333333329</c:v>
                </c:pt>
                <c:pt idx="2">
                  <c:v>79</c:v>
                </c:pt>
                <c:pt idx="3">
                  <c:v>70</c:v>
                </c:pt>
                <c:pt idx="4">
                  <c:v>60.333333333333336</c:v>
                </c:pt>
                <c:pt idx="5">
                  <c:v>52</c:v>
                </c:pt>
                <c:pt idx="6">
                  <c:v>40.333333333333329</c:v>
                </c:pt>
                <c:pt idx="7">
                  <c:v>25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Sheet3!$C$5</c:f>
              <c:strCache>
                <c:ptCount val="1"/>
                <c:pt idx="0">
                  <c:v>PF-06260933+Trametinib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Sheet3!$D$13:$K$13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5.0999999999999996</c:v>
                  </c:pt>
                  <c:pt idx="2">
                    <c:v>6.8</c:v>
                  </c:pt>
                  <c:pt idx="3">
                    <c:v>3.1</c:v>
                  </c:pt>
                  <c:pt idx="4">
                    <c:v>2.6</c:v>
                  </c:pt>
                  <c:pt idx="5">
                    <c:v>2</c:v>
                  </c:pt>
                  <c:pt idx="6">
                    <c:v>0.7</c:v>
                  </c:pt>
                  <c:pt idx="7">
                    <c:v>0.2</c:v>
                  </c:pt>
                </c:numCache>
              </c:numRef>
            </c:plus>
            <c:minus>
              <c:numRef>
                <c:f>Sheet3!$D$13:$K$13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5.0999999999999996</c:v>
                  </c:pt>
                  <c:pt idx="2">
                    <c:v>6.8</c:v>
                  </c:pt>
                  <c:pt idx="3">
                    <c:v>3.1</c:v>
                  </c:pt>
                  <c:pt idx="4">
                    <c:v>2.6</c:v>
                  </c:pt>
                  <c:pt idx="5">
                    <c:v>2</c:v>
                  </c:pt>
                  <c:pt idx="6">
                    <c:v>0.7</c:v>
                  </c:pt>
                  <c:pt idx="7">
                    <c:v>0.2</c:v>
                  </c:pt>
                </c:numCache>
              </c:numRef>
            </c:minus>
          </c:errBars>
          <c:cat>
            <c:strRef>
              <c:f>Sheet3!$D$2:$K$2</c:f>
              <c:strCache>
                <c:ptCount val="8"/>
                <c:pt idx="0">
                  <c:v>0/0</c:v>
                </c:pt>
                <c:pt idx="1">
                  <c:v>100/1</c:v>
                </c:pt>
                <c:pt idx="2">
                  <c:v>200/2</c:v>
                </c:pt>
                <c:pt idx="3">
                  <c:v>250/2.5</c:v>
                </c:pt>
                <c:pt idx="4">
                  <c:v>500/5</c:v>
                </c:pt>
                <c:pt idx="5">
                  <c:v>1000/10</c:v>
                </c:pt>
                <c:pt idx="6">
                  <c:v>2000/20</c:v>
                </c:pt>
                <c:pt idx="7">
                  <c:v>3000/30</c:v>
                </c:pt>
              </c:strCache>
            </c:strRef>
          </c:cat>
          <c:val>
            <c:numRef>
              <c:f>Sheet3!$D$5:$K$5</c:f>
              <c:numCache>
                <c:formatCode>General</c:formatCode>
                <c:ptCount val="8"/>
                <c:pt idx="0">
                  <c:v>100</c:v>
                </c:pt>
                <c:pt idx="1">
                  <c:v>77</c:v>
                </c:pt>
                <c:pt idx="2">
                  <c:v>61.333333333333329</c:v>
                </c:pt>
                <c:pt idx="3">
                  <c:v>53</c:v>
                </c:pt>
                <c:pt idx="4">
                  <c:v>37</c:v>
                </c:pt>
                <c:pt idx="5">
                  <c:v>20</c:v>
                </c:pt>
                <c:pt idx="6">
                  <c:v>11</c:v>
                </c:pt>
                <c:pt idx="7">
                  <c:v>2.333333333333333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84923904"/>
        <c:axId val="84925440"/>
      </c:lineChart>
      <c:catAx>
        <c:axId val="84923904"/>
        <c:scaling>
          <c:orientation val="minMax"/>
        </c:scaling>
        <c:delete val="0"/>
        <c:axPos val="b"/>
        <c:majorTickMark val="none"/>
        <c:minorTickMark val="in"/>
        <c:tickLblPos val="none"/>
        <c:spPr>
          <a:ln w="12700">
            <a:solidFill>
              <a:schemeClr val="tx1"/>
            </a:solidFill>
          </a:ln>
        </c:spPr>
        <c:crossAx val="84925440"/>
        <c:crosses val="autoZero"/>
        <c:auto val="1"/>
        <c:lblAlgn val="ctr"/>
        <c:lblOffset val="100"/>
        <c:noMultiLvlLbl val="0"/>
      </c:catAx>
      <c:valAx>
        <c:axId val="84925440"/>
        <c:scaling>
          <c:orientation val="minMax"/>
          <c:max val="10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900">
                <a:latin typeface="Arial" pitchFamily="34" charset="0"/>
                <a:cs typeface="Arial" pitchFamily="34" charset="0"/>
              </a:defRPr>
            </a:pPr>
            <a:endParaRPr lang="zh-CN"/>
          </a:p>
        </c:txPr>
        <c:crossAx val="8492390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0182526511540317"/>
          <c:y val="0.68283881156062021"/>
          <c:w val="0.45862576552930884"/>
          <c:h val="0.22452537182852145"/>
        </c:manualLayout>
      </c:layout>
      <c:overlay val="0"/>
      <c:txPr>
        <a:bodyPr/>
        <a:lstStyle/>
        <a:p>
          <a:pPr>
            <a:defRPr>
              <a:latin typeface="Arial" pitchFamily="34" charset="0"/>
              <a:cs typeface="Arial" pitchFamily="34" charset="0"/>
            </a:defRPr>
          </a:pPr>
          <a:endParaRPr lang="zh-CN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0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0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chart" Target="../charts/chart1.xml"/><Relationship Id="rId2" Type="http://schemas.openxmlformats.org/officeDocument/2006/relationships/hyperlink" Target="http://www.combosyn.com/" TargetMode="Externa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/>
          <p:cNvSpPr txBox="1"/>
          <p:nvPr/>
        </p:nvSpPr>
        <p:spPr>
          <a:xfrm>
            <a:off x="3491513" y="845066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72008" y="845066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2" name="TextBox 1"/>
          <p:cNvSpPr txBox="1"/>
          <p:nvPr/>
        </p:nvSpPr>
        <p:spPr>
          <a:xfrm>
            <a:off x="906716" y="4191000"/>
            <a:ext cx="7001217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4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–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current inhibition of MAP4K4 an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K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ert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synergistic effect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 lung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enocarcinoma cells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(A) pcDNA3.1-HA-MAP4K4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 pcDNA3.1-HA was transiently transfected into A549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nes followed by G418 selection. The established MAP4K4 overexpression cell lines (HA-M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an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cell lines (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A-C) were treated with 25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M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EK inhibitor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ametinib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or 48 hours. Cell lysates were collected for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mmuno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lot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 indicated antibodies. (B)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H23 cells were treated with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PF-06260933 (PF)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and </a:t>
            </a:r>
            <a:r>
              <a:rPr lang="en-US" altLang="zh-CN" sz="1200" dirty="0" err="1" smtClean="0">
                <a:latin typeface="Times New Roman" pitchFamily="18" charset="0"/>
                <a:cs typeface="Times New Roman" pitchFamily="18" charset="0"/>
              </a:rPr>
              <a:t>Trametinib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(</a:t>
            </a:r>
            <a:r>
              <a:rPr lang="en-US" altLang="zh-CN" sz="1200" dirty="0" err="1" smtClean="0">
                <a:latin typeface="Times New Roman" pitchFamily="18" charset="0"/>
                <a:cs typeface="Times New Roman" pitchFamily="18" charset="0"/>
              </a:rPr>
              <a:t>Tra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) at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indicated concentration for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4 days. Cell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viability was measured with MTT assay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rug synergism was analyzed using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mpuSy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oftware (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  <a:hlinkClick r:id="rId2"/>
              </a:rPr>
              <a:t>http://www.combosyn.co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Combination index (CI)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alu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ss than 0.75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dicate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ynergism.</a:t>
            </a:r>
          </a:p>
        </p:txBody>
      </p:sp>
      <p:pic>
        <p:nvPicPr>
          <p:cNvPr id="1026" name="Picture 2"/>
          <p:cNvPicPr>
            <a:picLocks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24837" y="2362200"/>
            <a:ext cx="1140906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" name="Picture 3"/>
          <p:cNvPicPr>
            <a:picLocks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9199" y="1768547"/>
            <a:ext cx="1143000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" name="Picture 4"/>
          <p:cNvPicPr>
            <a:picLocks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9198" y="2057400"/>
            <a:ext cx="1143000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9" name="Picture 5"/>
          <p:cNvPicPr>
            <a:picLocks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9198" y="2666999"/>
            <a:ext cx="1143000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576484" y="1768547"/>
            <a:ext cx="72227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-ERK1/2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654788" y="2057400"/>
            <a:ext cx="60821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ERK1/2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608765" y="2362200"/>
            <a:ext cx="68999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MAP4K4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654788" y="2666999"/>
            <a:ext cx="68999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501004" y="1560983"/>
            <a:ext cx="76200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ametinib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1295400" y="1545594"/>
            <a:ext cx="2286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1680990" y="1545594"/>
            <a:ext cx="2286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2057400" y="1545594"/>
            <a:ext cx="2286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1357903" y="1383732"/>
            <a:ext cx="55940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HA-C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1942753" y="1425036"/>
            <a:ext cx="5729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HA-M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Straight Connector 40"/>
          <p:cNvCxnSpPr/>
          <p:nvPr/>
        </p:nvCxnSpPr>
        <p:spPr>
          <a:xfrm>
            <a:off x="1224837" y="1425036"/>
            <a:ext cx="113736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/>
          <p:cNvSpPr txBox="1"/>
          <p:nvPr/>
        </p:nvSpPr>
        <p:spPr>
          <a:xfrm>
            <a:off x="1554559" y="1214398"/>
            <a:ext cx="54450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A549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Straight Connector 42"/>
          <p:cNvCxnSpPr/>
          <p:nvPr/>
        </p:nvCxnSpPr>
        <p:spPr>
          <a:xfrm flipV="1">
            <a:off x="1354163" y="1585356"/>
            <a:ext cx="449581" cy="349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5" name="Group 64"/>
          <p:cNvGrpSpPr/>
          <p:nvPr/>
        </p:nvGrpSpPr>
        <p:grpSpPr>
          <a:xfrm>
            <a:off x="3491513" y="1155393"/>
            <a:ext cx="4458150" cy="2827019"/>
            <a:chOff x="2201760" y="836712"/>
            <a:chExt cx="4458150" cy="2827019"/>
          </a:xfrm>
        </p:grpSpPr>
        <p:graphicFrame>
          <p:nvGraphicFramePr>
            <p:cNvPr id="66" name="图表 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772496620"/>
                </p:ext>
              </p:extLst>
            </p:nvPr>
          </p:nvGraphicFramePr>
          <p:xfrm>
            <a:off x="2411760" y="836712"/>
            <a:ext cx="4248150" cy="252028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67" name="TextBox 66"/>
            <p:cNvSpPr txBox="1"/>
            <p:nvPr/>
          </p:nvSpPr>
          <p:spPr>
            <a:xfrm>
              <a:off x="2204100" y="1052736"/>
              <a:ext cx="323165" cy="2042105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>
                <a:defRPr sz="10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lative Cell Viability (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2225876" y="3253491"/>
              <a:ext cx="7200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F (</a:t>
              </a:r>
              <a:r>
                <a:rPr lang="en-US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5667016" y="1189260"/>
              <a:ext cx="67302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I=0.3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3256962" y="3253491"/>
              <a:ext cx="43204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3749070" y="3253491"/>
              <a:ext cx="43204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4225708" y="3253491"/>
              <a:ext cx="43204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4716682" y="3253491"/>
              <a:ext cx="43204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0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5148730" y="3253491"/>
              <a:ext cx="48379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0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2201760" y="3432899"/>
              <a:ext cx="7200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Tra</a:t>
              </a:r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6104427" y="3253491"/>
              <a:ext cx="48379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00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5632527" y="3253491"/>
              <a:ext cx="48379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00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2895498" y="3432899"/>
              <a:ext cx="28647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2891335" y="3253491"/>
              <a:ext cx="28647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3347557" y="3432899"/>
              <a:ext cx="24617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3836302" y="3432899"/>
              <a:ext cx="25290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4247709" y="3432899"/>
              <a:ext cx="43204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.5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4786350" y="3432899"/>
              <a:ext cx="43204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5224311" y="3432899"/>
              <a:ext cx="48379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6174095" y="3432899"/>
              <a:ext cx="48379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5690298" y="3432899"/>
              <a:ext cx="48379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5733399" y="1033608"/>
              <a:ext cx="49777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23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2155610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4</TotalTime>
  <Words>54</Words>
  <Application>Microsoft Office PowerPoint</Application>
  <PresentationFormat>全屏显示(4:3)</PresentationFormat>
  <Paragraphs>35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Theme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o, Chenxi</dc:creator>
  <cp:lastModifiedBy>xbany</cp:lastModifiedBy>
  <cp:revision>29</cp:revision>
  <dcterms:created xsi:type="dcterms:W3CDTF">2006-08-16T00:00:00Z</dcterms:created>
  <dcterms:modified xsi:type="dcterms:W3CDTF">2017-03-30T14:20:54Z</dcterms:modified>
</cp:coreProperties>
</file>